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2" r:id="rId2"/>
    <p:sldId id="263" r:id="rId3"/>
    <p:sldId id="265" r:id="rId4"/>
    <p:sldId id="257" r:id="rId5"/>
    <p:sldId id="259" r:id="rId6"/>
    <p:sldId id="267" r:id="rId7"/>
    <p:sldId id="264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Xiaolong\Documents\Experimental%20data\Rockford\Real-Time%20Results\SRp20%20project\7-24-14%20chip%20p53,%20Bripi,%20Rad51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Xiaolong\Documents\Experimental%20data\Rockford\Real-Time%20Results\SRp20%20project\7-24-14%20chip%20p53,%20Bripi,%20Rad51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Xiaolong\Documents\Experimental%20data\Rockford\Real-Time%20Results\SRp20%20project\7-24-14%20chip%20p53,%20Bripi,%20Rad51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Xiaolong\Documents\Experimental%20data\Rockford\Real-Time%20Results\SRp20%20project\7-24-14%20chip%20p53,%20Bripi,%20Rad5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RCA1</a:t>
            </a:r>
          </a:p>
        </c:rich>
      </c:tx>
      <c:layout>
        <c:manualLayout>
          <c:xMode val="edge"/>
          <c:yMode val="edge"/>
          <c:x val="0.38945736434108524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9293242995788316"/>
          <c:y val="0.16714129483814522"/>
          <c:w val="0.64733101385582614"/>
          <c:h val="0.71687882764654431"/>
        </c:manualLayout>
      </c:layout>
      <c:barChart>
        <c:barDir val="col"/>
        <c:grouping val="clustered"/>
        <c:varyColors val="0"/>
        <c:ser>
          <c:idx val="0"/>
          <c:order val="0"/>
          <c:tx>
            <c:v>RNApII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RCA1-2'!$D$4:$E$4</c:f>
                <c:numCache>
                  <c:formatCode>General</c:formatCode>
                  <c:ptCount val="2"/>
                  <c:pt idx="0">
                    <c:v>1.06582241E-2</c:v>
                  </c:pt>
                  <c:pt idx="1">
                    <c:v>1.5976533541863201E-2</c:v>
                  </c:pt>
                </c:numCache>
              </c:numRef>
            </c:plus>
            <c:minus>
              <c:numRef>
                <c:f>'BRCA1-2'!$D$4:$E$4</c:f>
                <c:numCache>
                  <c:formatCode>General</c:formatCode>
                  <c:ptCount val="2"/>
                  <c:pt idx="0">
                    <c:v>1.06582241E-2</c:v>
                  </c:pt>
                  <c:pt idx="1">
                    <c:v>1.5976533541863201E-2</c:v>
                  </c:pt>
                </c:numCache>
              </c:numRef>
            </c:minus>
          </c:errBars>
          <c:cat>
            <c:strRef>
              <c:f>'BRCA1-2'!$B$3:$C$3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BRCA1-2'!$B$4:$C$4</c:f>
              <c:numCache>
                <c:formatCode>General</c:formatCode>
                <c:ptCount val="2"/>
                <c:pt idx="0">
                  <c:v>0.696154238421544</c:v>
                </c:pt>
                <c:pt idx="1">
                  <c:v>0.20126432679821701</c:v>
                </c:pt>
              </c:numCache>
            </c:numRef>
          </c:val>
        </c:ser>
        <c:ser>
          <c:idx val="1"/>
          <c:order val="1"/>
          <c:tx>
            <c:v>Neg 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RCA1-2'!$D$5:$E$5</c:f>
                <c:numCache>
                  <c:formatCode>General</c:formatCode>
                  <c:ptCount val="2"/>
                  <c:pt idx="0">
                    <c:v>2.3162314564120701E-2</c:v>
                  </c:pt>
                  <c:pt idx="1">
                    <c:v>9.3212346662157799E-3</c:v>
                  </c:pt>
                </c:numCache>
              </c:numRef>
            </c:plus>
            <c:minus>
              <c:numRef>
                <c:f>'BRCA1-2'!$D$5:$E$5</c:f>
                <c:numCache>
                  <c:formatCode>General</c:formatCode>
                  <c:ptCount val="2"/>
                  <c:pt idx="0">
                    <c:v>2.3162314564120701E-2</c:v>
                  </c:pt>
                  <c:pt idx="1">
                    <c:v>9.3212346662157799E-3</c:v>
                  </c:pt>
                </c:numCache>
              </c:numRef>
            </c:minus>
          </c:errBars>
          <c:cat>
            <c:strRef>
              <c:f>'BRCA1-2'!$B$3:$C$3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BRCA1-2'!$B$5:$C$5</c:f>
              <c:numCache>
                <c:formatCode>General</c:formatCode>
                <c:ptCount val="2"/>
                <c:pt idx="0">
                  <c:v>5.9365113375229601E-2</c:v>
                </c:pt>
                <c:pt idx="1">
                  <c:v>4.542156333329999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352256"/>
        <c:axId val="142577024"/>
      </c:barChart>
      <c:catAx>
        <c:axId val="120352256"/>
        <c:scaling>
          <c:orientation val="minMax"/>
        </c:scaling>
        <c:delete val="0"/>
        <c:axPos val="b"/>
        <c:majorTickMark val="out"/>
        <c:minorTickMark val="none"/>
        <c:tickLblPos val="nextTo"/>
        <c:crossAx val="142577024"/>
        <c:crosses val="autoZero"/>
        <c:auto val="1"/>
        <c:lblAlgn val="ctr"/>
        <c:lblOffset val="100"/>
        <c:noMultiLvlLbl val="0"/>
      </c:catAx>
      <c:valAx>
        <c:axId val="142577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Inpout</a:t>
                </a:r>
              </a:p>
            </c:rich>
          </c:tx>
          <c:layout>
            <c:manualLayout>
              <c:xMode val="edge"/>
              <c:yMode val="edge"/>
              <c:x val="4.7066349264481479E-2"/>
              <c:y val="0.360881452318460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03522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8233192943905276"/>
          <c:y val="0.18017169728783905"/>
          <c:w val="0.30334663980955867"/>
          <c:h val="0.1257677165354330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RIP1</a:t>
            </a:r>
          </a:p>
        </c:rich>
      </c:tx>
      <c:layout>
        <c:manualLayout>
          <c:xMode val="edge"/>
          <c:yMode val="edge"/>
          <c:x val="0.3582015503875968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9293242995788316"/>
          <c:y val="0.16714129483814522"/>
          <c:w val="0.64733101385582614"/>
          <c:h val="0.71687882764654431"/>
        </c:manualLayout>
      </c:layout>
      <c:barChart>
        <c:barDir val="col"/>
        <c:grouping val="clustered"/>
        <c:varyColors val="0"/>
        <c:ser>
          <c:idx val="0"/>
          <c:order val="0"/>
          <c:tx>
            <c:v>RNApII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BRIP1-2'!$D$3:$E$3</c:f>
                <c:numCache>
                  <c:formatCode>General</c:formatCode>
                  <c:ptCount val="2"/>
                  <c:pt idx="0">
                    <c:v>0.13567812739016299</c:v>
                  </c:pt>
                  <c:pt idx="1">
                    <c:v>0.107253385422445</c:v>
                  </c:pt>
                </c:numCache>
              </c:numRef>
            </c:plus>
            <c:minus>
              <c:numRef>
                <c:f>'BRIP1-2'!$D$3:$E$3</c:f>
                <c:numCache>
                  <c:formatCode>General</c:formatCode>
                  <c:ptCount val="2"/>
                  <c:pt idx="0">
                    <c:v>0.13567812739016299</c:v>
                  </c:pt>
                  <c:pt idx="1">
                    <c:v>0.107253385422445</c:v>
                  </c:pt>
                </c:numCache>
              </c:numRef>
            </c:minus>
          </c:errBars>
          <c:cat>
            <c:strRef>
              <c:f>'BRIP1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BRIP1-2'!$B$3:$C$3</c:f>
              <c:numCache>
                <c:formatCode>General</c:formatCode>
                <c:ptCount val="2"/>
                <c:pt idx="0">
                  <c:v>2.3036325725672402</c:v>
                </c:pt>
                <c:pt idx="1">
                  <c:v>0.55245677539419802</c:v>
                </c:pt>
              </c:numCache>
            </c:numRef>
          </c:val>
        </c:ser>
        <c:ser>
          <c:idx val="1"/>
          <c:order val="1"/>
          <c:tx>
            <c:v>Neg 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RIP1-2'!$D$4:$E$4</c:f>
                <c:numCache>
                  <c:formatCode>General</c:formatCode>
                  <c:ptCount val="2"/>
                  <c:pt idx="0">
                    <c:v>1.34566222454565E-2</c:v>
                  </c:pt>
                  <c:pt idx="1">
                    <c:v>1.11138672207165E-2</c:v>
                  </c:pt>
                </c:numCache>
              </c:numRef>
            </c:plus>
            <c:minus>
              <c:numRef>
                <c:f>'BRIP1-2'!$D$4:$E$4</c:f>
                <c:numCache>
                  <c:formatCode>General</c:formatCode>
                  <c:ptCount val="2"/>
                  <c:pt idx="0">
                    <c:v>1.34566222454565E-2</c:v>
                  </c:pt>
                  <c:pt idx="1">
                    <c:v>1.11138672207165E-2</c:v>
                  </c:pt>
                </c:numCache>
              </c:numRef>
            </c:minus>
          </c:errBars>
          <c:cat>
            <c:strRef>
              <c:f>'BRIP1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BRIP1-2'!$B$4:$C$4</c:f>
              <c:numCache>
                <c:formatCode>General</c:formatCode>
                <c:ptCount val="2"/>
                <c:pt idx="0">
                  <c:v>5.7348703245126698E-2</c:v>
                </c:pt>
                <c:pt idx="1">
                  <c:v>5.234671245273409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1320192"/>
        <c:axId val="142578752"/>
      </c:barChart>
      <c:catAx>
        <c:axId val="141320192"/>
        <c:scaling>
          <c:orientation val="minMax"/>
        </c:scaling>
        <c:delete val="0"/>
        <c:axPos val="b"/>
        <c:majorTickMark val="out"/>
        <c:minorTickMark val="none"/>
        <c:tickLblPos val="nextTo"/>
        <c:crossAx val="142578752"/>
        <c:crosses val="autoZero"/>
        <c:auto val="1"/>
        <c:lblAlgn val="ctr"/>
        <c:lblOffset val="100"/>
        <c:noMultiLvlLbl val="0"/>
      </c:catAx>
      <c:valAx>
        <c:axId val="142578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Inpout</a:t>
                </a:r>
              </a:p>
            </c:rich>
          </c:tx>
          <c:layout>
            <c:manualLayout>
              <c:xMode val="edge"/>
              <c:yMode val="edge"/>
              <c:x val="4.7066349264481479E-2"/>
              <c:y val="0.360881452318460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13201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8233192943905276"/>
          <c:y val="0.18017169728783905"/>
          <c:w val="0.30334663980955867"/>
          <c:h val="0.1257677165354330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RAD51</a:t>
            </a:r>
          </a:p>
        </c:rich>
      </c:tx>
      <c:layout>
        <c:manualLayout>
          <c:xMode val="edge"/>
          <c:yMode val="edge"/>
          <c:x val="0.39880607947262409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9293242995788316"/>
          <c:y val="0.16714129483814522"/>
          <c:w val="0.64733101385582614"/>
          <c:h val="0.71687882764654431"/>
        </c:manualLayout>
      </c:layout>
      <c:barChart>
        <c:barDir val="col"/>
        <c:grouping val="clustered"/>
        <c:varyColors val="0"/>
        <c:ser>
          <c:idx val="0"/>
          <c:order val="0"/>
          <c:tx>
            <c:v>RNApII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RAD51-2'!$D$3:$E$3</c:f>
                <c:numCache>
                  <c:formatCode>General</c:formatCode>
                  <c:ptCount val="2"/>
                  <c:pt idx="0">
                    <c:v>8.5345624567744194E-2</c:v>
                  </c:pt>
                  <c:pt idx="1">
                    <c:v>4.2348644321643501E-2</c:v>
                  </c:pt>
                </c:numCache>
              </c:numRef>
            </c:plus>
            <c:minus>
              <c:numRef>
                <c:f>'RAD51-2'!$D$3:$E$3</c:f>
                <c:numCache>
                  <c:formatCode>General</c:formatCode>
                  <c:ptCount val="2"/>
                  <c:pt idx="0">
                    <c:v>8.5345624567744194E-2</c:v>
                  </c:pt>
                  <c:pt idx="1">
                    <c:v>4.2348644321643501E-2</c:v>
                  </c:pt>
                </c:numCache>
              </c:numRef>
            </c:minus>
          </c:errBars>
          <c:cat>
            <c:strRef>
              <c:f>'RAD51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RAD51-2'!$B$3:$C$3</c:f>
              <c:numCache>
                <c:formatCode>General</c:formatCode>
                <c:ptCount val="2"/>
                <c:pt idx="0">
                  <c:v>1.90134816412457</c:v>
                </c:pt>
                <c:pt idx="1">
                  <c:v>0.3392174842381</c:v>
                </c:pt>
              </c:numCache>
            </c:numRef>
          </c:val>
        </c:ser>
        <c:ser>
          <c:idx val="1"/>
          <c:order val="1"/>
          <c:tx>
            <c:v>Neg 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AD51-2'!$D$4:$E$4</c:f>
                <c:numCache>
                  <c:formatCode>General</c:formatCode>
                  <c:ptCount val="2"/>
                  <c:pt idx="0">
                    <c:v>2.36610949245088E-2</c:v>
                  </c:pt>
                  <c:pt idx="1">
                    <c:v>1.3011352683285101E-2</c:v>
                  </c:pt>
                </c:numCache>
              </c:numRef>
            </c:plus>
            <c:minus>
              <c:numRef>
                <c:f>'RAD51-2'!$D$4:$E$4</c:f>
                <c:numCache>
                  <c:formatCode>General</c:formatCode>
                  <c:ptCount val="2"/>
                  <c:pt idx="0">
                    <c:v>2.36610949245088E-2</c:v>
                  </c:pt>
                  <c:pt idx="1">
                    <c:v>1.3011352683285101E-2</c:v>
                  </c:pt>
                </c:numCache>
              </c:numRef>
            </c:minus>
          </c:errBars>
          <c:cat>
            <c:strRef>
              <c:f>'RAD51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RAD51-2'!$B$4:$C$4</c:f>
              <c:numCache>
                <c:formatCode>General</c:formatCode>
                <c:ptCount val="2"/>
                <c:pt idx="0">
                  <c:v>2.57345257213457E-2</c:v>
                </c:pt>
                <c:pt idx="1">
                  <c:v>2.410564477123480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1321728"/>
        <c:axId val="142580480"/>
      </c:barChart>
      <c:catAx>
        <c:axId val="141321728"/>
        <c:scaling>
          <c:orientation val="minMax"/>
        </c:scaling>
        <c:delete val="0"/>
        <c:axPos val="b"/>
        <c:majorTickMark val="out"/>
        <c:minorTickMark val="none"/>
        <c:tickLblPos val="nextTo"/>
        <c:crossAx val="142580480"/>
        <c:crosses val="autoZero"/>
        <c:auto val="1"/>
        <c:lblAlgn val="ctr"/>
        <c:lblOffset val="100"/>
        <c:noMultiLvlLbl val="0"/>
      </c:catAx>
      <c:valAx>
        <c:axId val="142580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Inpout</a:t>
                </a:r>
              </a:p>
            </c:rich>
          </c:tx>
          <c:layout>
            <c:manualLayout>
              <c:xMode val="edge"/>
              <c:yMode val="edge"/>
              <c:x val="4.7066349264481479E-2"/>
              <c:y val="0.360881452318460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13217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8233192943905276"/>
          <c:y val="0.18017169728783905"/>
          <c:w val="0.30334663980955867"/>
          <c:h val="0.1257677165354330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GAPDH</a:t>
            </a:r>
          </a:p>
        </c:rich>
      </c:tx>
      <c:layout>
        <c:manualLayout>
          <c:xMode val="edge"/>
          <c:yMode val="edge"/>
          <c:x val="0.36773631203076362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9293242995788316"/>
          <c:y val="0.16714129483814522"/>
          <c:w val="0.64733101385582614"/>
          <c:h val="0.71687882764654431"/>
        </c:manualLayout>
      </c:layout>
      <c:barChart>
        <c:barDir val="col"/>
        <c:grouping val="clustered"/>
        <c:varyColors val="0"/>
        <c:ser>
          <c:idx val="0"/>
          <c:order val="0"/>
          <c:tx>
            <c:v>RNApII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GAPDH-2'!$D$3:$E$3</c:f>
                <c:numCache>
                  <c:formatCode>General</c:formatCode>
                  <c:ptCount val="2"/>
                  <c:pt idx="0">
                    <c:v>0.71728036781358295</c:v>
                  </c:pt>
                  <c:pt idx="1">
                    <c:v>0.183162367833683</c:v>
                  </c:pt>
                </c:numCache>
              </c:numRef>
            </c:plus>
            <c:minus>
              <c:numRef>
                <c:f>'GAPDH-2'!$D$3:$E$3</c:f>
                <c:numCache>
                  <c:formatCode>General</c:formatCode>
                  <c:ptCount val="2"/>
                  <c:pt idx="0">
                    <c:v>0.71728036781358295</c:v>
                  </c:pt>
                  <c:pt idx="1">
                    <c:v>0.183162367833683</c:v>
                  </c:pt>
                </c:numCache>
              </c:numRef>
            </c:minus>
          </c:errBars>
          <c:cat>
            <c:strRef>
              <c:f>'GAPDH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GAPDH-2'!$B$3:$C$3</c:f>
              <c:numCache>
                <c:formatCode>General</c:formatCode>
                <c:ptCount val="2"/>
                <c:pt idx="0">
                  <c:v>6.4513452937154696</c:v>
                </c:pt>
                <c:pt idx="1">
                  <c:v>6.3925315676743004</c:v>
                </c:pt>
              </c:numCache>
            </c:numRef>
          </c:val>
        </c:ser>
        <c:ser>
          <c:idx val="1"/>
          <c:order val="1"/>
          <c:tx>
            <c:v>Neg 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APDH-2'!$D$4:$E$4</c:f>
                <c:numCache>
                  <c:formatCode>General</c:formatCode>
                  <c:ptCount val="2"/>
                  <c:pt idx="0">
                    <c:v>3.2146527446874303E-2</c:v>
                  </c:pt>
                  <c:pt idx="1">
                    <c:v>9.5231793462471598E-2</c:v>
                  </c:pt>
                </c:numCache>
              </c:numRef>
            </c:plus>
            <c:minus>
              <c:numRef>
                <c:f>'GAPDH-2'!$D$4:$E$4</c:f>
                <c:numCache>
                  <c:formatCode>General</c:formatCode>
                  <c:ptCount val="2"/>
                  <c:pt idx="0">
                    <c:v>3.2146527446874303E-2</c:v>
                  </c:pt>
                  <c:pt idx="1">
                    <c:v>9.5231793462471598E-2</c:v>
                  </c:pt>
                </c:numCache>
              </c:numRef>
            </c:minus>
          </c:errBars>
          <c:cat>
            <c:strRef>
              <c:f>'GAPDH-2'!$B$2:$C$2</c:f>
              <c:strCache>
                <c:ptCount val="2"/>
                <c:pt idx="0">
                  <c:v>No Doxy</c:v>
                </c:pt>
                <c:pt idx="1">
                  <c:v>Doxy</c:v>
                </c:pt>
              </c:strCache>
            </c:strRef>
          </c:cat>
          <c:val>
            <c:numRef>
              <c:f>'GAPDH-2'!$B$4:$C$4</c:f>
              <c:numCache>
                <c:formatCode>General</c:formatCode>
                <c:ptCount val="2"/>
                <c:pt idx="0">
                  <c:v>7.8294156788822997E-2</c:v>
                </c:pt>
                <c:pt idx="1">
                  <c:v>0.1461739428021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1322240"/>
        <c:axId val="141566528"/>
      </c:barChart>
      <c:catAx>
        <c:axId val="141322240"/>
        <c:scaling>
          <c:orientation val="minMax"/>
        </c:scaling>
        <c:delete val="0"/>
        <c:axPos val="b"/>
        <c:majorTickMark val="out"/>
        <c:minorTickMark val="none"/>
        <c:tickLblPos val="nextTo"/>
        <c:crossAx val="141566528"/>
        <c:crosses val="autoZero"/>
        <c:auto val="1"/>
        <c:lblAlgn val="ctr"/>
        <c:lblOffset val="100"/>
        <c:noMultiLvlLbl val="0"/>
      </c:catAx>
      <c:valAx>
        <c:axId val="141566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Inpout</a:t>
                </a:r>
              </a:p>
            </c:rich>
          </c:tx>
          <c:layout>
            <c:manualLayout>
              <c:xMode val="edge"/>
              <c:yMode val="edge"/>
              <c:x val="4.7066349264481479E-2"/>
              <c:y val="0.360881452318460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413222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5742782152231"/>
          <c:y val="0.12924577136191309"/>
          <c:w val="0.30334663980955867"/>
          <c:h val="0.1257677165354330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8A095A-2CAD-4584-B042-43F21FF479C8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13010A-8F79-4CB3-BD7E-98B528A4B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663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DC5A50-5F8F-4843-A12D-B4C9CB9D2DB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5546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13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809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508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73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81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67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79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141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446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332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708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6BF0F8-7A45-4280-A94E-AC942090F7DE}" type="datetimeFigureOut">
              <a:rPr lang="en-US" smtClean="0"/>
              <a:t>7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D46A6-6691-415D-A575-2C50F6AC21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2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16.png"/><Relationship Id="rId7" Type="http://schemas.openxmlformats.org/officeDocument/2006/relationships/chart" Target="../charts/chart2.xml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chart" Target="../charts/char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37" y="914400"/>
            <a:ext cx="6370063" cy="4191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95600" y="609600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erol metabolic proces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2400" y="323076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8315584"/>
              </p:ext>
            </p:extLst>
          </p:nvPr>
        </p:nvGraphicFramePr>
        <p:xfrm>
          <a:off x="6705600" y="1399080"/>
          <a:ext cx="2057400" cy="3221639"/>
        </p:xfrm>
        <a:graphic>
          <a:graphicData uri="http://schemas.openxmlformats.org/drawingml/2006/table">
            <a:tbl>
              <a:tblPr/>
              <a:tblGrid>
                <a:gridCol w="959686"/>
                <a:gridCol w="1097714"/>
              </a:tblGrid>
              <a:tr h="2667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erol Biosynthetic proces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641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Symbo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ld Changes (Doxy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s No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oxy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MGCS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755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P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189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QL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964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HCR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6054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MO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58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SDH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927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5D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3819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MGC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45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B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0449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51A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9983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VK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834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S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80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14orf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7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V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2819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SIG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2450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58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DI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816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52400" y="942201"/>
            <a:ext cx="419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286500" y="987623"/>
            <a:ext cx="419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49000" y="5257800"/>
            <a:ext cx="808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Genes involved  in sterol biosynthetic process are enriched among expression-altered genes in SRSF3-knockdown cells. (A)  Bar chart of enrichment scores under the term of stero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tabolic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ocess generated by gene ontology analysis.  (B) List of genes involved in sterol biosynthetic process. 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14111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7620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914400"/>
            <a:ext cx="5580355" cy="3781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4707608"/>
              </p:ext>
            </p:extLst>
          </p:nvPr>
        </p:nvGraphicFramePr>
        <p:xfrm>
          <a:off x="5866105" y="383977"/>
          <a:ext cx="3124200" cy="5135230"/>
        </p:xfrm>
        <a:graphic>
          <a:graphicData uri="http://schemas.openxmlformats.org/drawingml/2006/table">
            <a:tbl>
              <a:tblPr/>
              <a:tblGrid>
                <a:gridCol w="943386"/>
                <a:gridCol w="980141"/>
                <a:gridCol w="1200673"/>
              </a:tblGrid>
              <a:tr h="395917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 </a:t>
                      </a:r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lyubiquitina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54" marR="8754" marT="87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54" marR="8754" marT="87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91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Symbol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t-splicing p-value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ld Changes in Overall Expression (Doxy vs No Doxy)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BCK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71E-0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775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IM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6E-0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0440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PEPPS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2E-0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2184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4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17E-0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791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SMA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64E-0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9607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KS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9E-0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731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21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5453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59439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BXO2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9909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6223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DAC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25491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18139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DD4L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30952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0424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SMD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33082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348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SME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41991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317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SMD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44365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05309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OX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54743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742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E2D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5649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7502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NF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56880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0158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RSAM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578335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7643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PIL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63880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930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E2D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966032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2557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SMA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1472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82379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SH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3684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6468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E2H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67144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4299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RCH6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9675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45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1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E2G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28073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25801</a:t>
                      </a:r>
                    </a:p>
                  </a:txBody>
                  <a:tcPr marL="8754" marR="8754" marT="875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62890" y="609600"/>
            <a:ext cx="419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10200" y="149423"/>
            <a:ext cx="419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Rectangle 8"/>
          <p:cNvSpPr/>
          <p:nvPr/>
        </p:nvSpPr>
        <p:spPr>
          <a:xfrm>
            <a:off x="449000" y="5830669"/>
            <a:ext cx="808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Genes related to protein ubiquitination are enriched among splicing-altered genes in SRSF3-knockdown cells. (A)  Bar chart of enrichment scores under the term of protein ubiquitination generated by gene ontology analysis.  (B) List of genes involved in protein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ubiquitinatio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286000" y="609601"/>
            <a:ext cx="2209800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tein ubiquitinatio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10539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838200" y="1693547"/>
            <a:ext cx="3405552" cy="2573653"/>
            <a:chOff x="1066800" y="757535"/>
            <a:chExt cx="3405552" cy="2573653"/>
          </a:xfrm>
        </p:grpSpPr>
        <p:grpSp>
          <p:nvGrpSpPr>
            <p:cNvPr id="2" name="Group 1"/>
            <p:cNvGrpSpPr/>
            <p:nvPr/>
          </p:nvGrpSpPr>
          <p:grpSpPr>
            <a:xfrm>
              <a:off x="1257300" y="757535"/>
              <a:ext cx="3167055" cy="690265"/>
              <a:chOff x="1257300" y="757535"/>
              <a:chExt cx="3167055" cy="690265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1257300" y="1170801"/>
                <a:ext cx="31623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y         +        -        +        -        +         -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" name="Straight Connector 3"/>
              <p:cNvCxnSpPr/>
              <p:nvPr/>
            </p:nvCxnSpPr>
            <p:spPr>
              <a:xfrm>
                <a:off x="1905000" y="1219200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/>
              <p:cNvCxnSpPr/>
              <p:nvPr/>
            </p:nvCxnSpPr>
            <p:spPr>
              <a:xfrm>
                <a:off x="2819400" y="1219200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5"/>
              <p:cNvCxnSpPr/>
              <p:nvPr/>
            </p:nvCxnSpPr>
            <p:spPr>
              <a:xfrm>
                <a:off x="3634971" y="1219200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1981200" y="849868"/>
                <a:ext cx="817756" cy="36933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A2780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RSF3si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743200" y="762000"/>
                <a:ext cx="92734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A2780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RSF3si2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657600" y="757535"/>
                <a:ext cx="76675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2780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UCsi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1143000" y="1447800"/>
              <a:ext cx="3309727" cy="446906"/>
              <a:chOff x="1241829" y="3210694"/>
              <a:chExt cx="3309727" cy="446906"/>
            </a:xfrm>
          </p:grpSpPr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4999" y="3210694"/>
                <a:ext cx="2646557" cy="4469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1241829" y="3319046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RCC2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1066800" y="1931320"/>
              <a:ext cx="3385926" cy="457200"/>
              <a:chOff x="1066800" y="4038600"/>
              <a:chExt cx="3385926" cy="457200"/>
            </a:xfrm>
          </p:grpSpPr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06170" y="4038600"/>
                <a:ext cx="2646556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1066800" y="4114800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D54B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066800" y="2950188"/>
              <a:ext cx="3381130" cy="381000"/>
              <a:chOff x="1056727" y="4953000"/>
              <a:chExt cx="3381130" cy="381000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1056727" y="4953000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" name="Picture 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6097" y="4953000"/>
                <a:ext cx="2641760" cy="381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1295400" y="2454735"/>
              <a:ext cx="3176952" cy="457200"/>
              <a:chOff x="1307315" y="5562600"/>
              <a:chExt cx="3176952" cy="457200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1307315" y="5605046"/>
                <a:ext cx="6250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M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1" name="Picture 7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18085" y="5562600"/>
                <a:ext cx="2666182" cy="457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23" name="TextBox 22"/>
          <p:cNvSpPr txBox="1"/>
          <p:nvPr/>
        </p:nvSpPr>
        <p:spPr>
          <a:xfrm>
            <a:off x="990600" y="1368623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480560" y="1292423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7139327"/>
              </p:ext>
            </p:extLst>
          </p:nvPr>
        </p:nvGraphicFramePr>
        <p:xfrm>
          <a:off x="4724400" y="1992781"/>
          <a:ext cx="4038014" cy="2123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90600"/>
                <a:gridCol w="1066800"/>
                <a:gridCol w="1108625"/>
                <a:gridCol w="871989"/>
              </a:tblGrid>
              <a:tr h="370840">
                <a:tc gridSpan="4"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Fold changes between cells treated with and without Doxy determined by </a:t>
                      </a:r>
                      <a:r>
                        <a:rPr lang="en-US" b="1" dirty="0" err="1" smtClean="0"/>
                        <a:t>qPCR</a:t>
                      </a:r>
                      <a:endParaRPr lang="en-US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ene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SRSF3si1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SRSF3si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err="1" smtClean="0"/>
                        <a:t>LUCsi</a:t>
                      </a:r>
                      <a:endParaRPr lang="en-US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XRCC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3.1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8.2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.02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RAD54B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3.6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6.4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.09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BLM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2.9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5.68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.57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381000" y="228600"/>
            <a:ext cx="10668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27" name="Rectangle 26"/>
          <p:cNvSpPr/>
          <p:nvPr/>
        </p:nvSpPr>
        <p:spPr>
          <a:xfrm>
            <a:off x="449000" y="4648200"/>
            <a:ext cx="8085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–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firmation of th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wnregulati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XRCC2, RAD54B and BLM afte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RSF3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nockdown.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Regular RT-PCR results. (B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esult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28364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258499" y="1575456"/>
            <a:ext cx="4055002" cy="2558713"/>
            <a:chOff x="609600" y="1671935"/>
            <a:chExt cx="4055002" cy="2558713"/>
          </a:xfrm>
        </p:grpSpPr>
        <p:grpSp>
          <p:nvGrpSpPr>
            <p:cNvPr id="3" name="Group 2"/>
            <p:cNvGrpSpPr/>
            <p:nvPr/>
          </p:nvGrpSpPr>
          <p:grpSpPr>
            <a:xfrm>
              <a:off x="762000" y="2325051"/>
              <a:ext cx="3897686" cy="461962"/>
              <a:chOff x="1447800" y="1371601"/>
              <a:chExt cx="3897686" cy="461962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57400" y="1371601"/>
                <a:ext cx="3288086" cy="4619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447800" y="151275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762000" y="3289269"/>
              <a:ext cx="3897686" cy="528638"/>
              <a:chOff x="1447800" y="1906436"/>
              <a:chExt cx="3897686" cy="528638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57400" y="1906436"/>
                <a:ext cx="3288086" cy="528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1447800" y="2023319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D5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778402" y="2822491"/>
              <a:ext cx="3886200" cy="447368"/>
              <a:chOff x="1459286" y="2569107"/>
              <a:chExt cx="3886200" cy="447368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57400" y="2569107"/>
                <a:ext cx="3288086" cy="4473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459286" y="2723796"/>
                <a:ext cx="76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IP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762000" y="1671935"/>
              <a:ext cx="3897686" cy="690265"/>
              <a:chOff x="1447800" y="718485"/>
              <a:chExt cx="3897686" cy="690265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1447800" y="1131751"/>
                <a:ext cx="38976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y         +           -           +           -           +           -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2209800" y="1180150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3276600" y="1185446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4343400" y="1185446"/>
                <a:ext cx="7620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2306444" y="722950"/>
                <a:ext cx="970156" cy="36933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KOV3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RSF3si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360304" y="722950"/>
                <a:ext cx="105929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KOV3/</a:t>
                </a:r>
              </a:p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RSF3si2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343400" y="718485"/>
                <a:ext cx="7620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KOV3/</a:t>
                </a:r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UCsi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609600" y="3832560"/>
              <a:ext cx="4038600" cy="398088"/>
              <a:chOff x="2514600" y="3869112"/>
              <a:chExt cx="4038600" cy="398088"/>
            </a:xfrm>
          </p:grpSpPr>
          <p:pic>
            <p:nvPicPr>
              <p:cNvPr id="12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65114" y="3869112"/>
                <a:ext cx="3288086" cy="3980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2514600" y="3928646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3" name="TextBox 12"/>
          <p:cNvSpPr txBox="1"/>
          <p:nvPr/>
        </p:nvSpPr>
        <p:spPr>
          <a:xfrm>
            <a:off x="381000" y="228600"/>
            <a:ext cx="10668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4762500" y="1740322"/>
            <a:ext cx="4038600" cy="2280758"/>
            <a:chOff x="4953000" y="1828800"/>
            <a:chExt cx="4038600" cy="2280758"/>
          </a:xfrm>
        </p:grpSpPr>
        <p:grpSp>
          <p:nvGrpSpPr>
            <p:cNvPr id="10" name="Group 9"/>
            <p:cNvGrpSpPr/>
            <p:nvPr/>
          </p:nvGrpSpPr>
          <p:grpSpPr>
            <a:xfrm>
              <a:off x="5029200" y="2971800"/>
              <a:ext cx="3596640" cy="359810"/>
              <a:chOff x="5029200" y="2755869"/>
              <a:chExt cx="3596640" cy="533400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38800" y="2755869"/>
                <a:ext cx="2987040" cy="533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5029200" y="2895600"/>
                <a:ext cx="76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IP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5029200" y="3400037"/>
              <a:ext cx="3606472" cy="333763"/>
              <a:chOff x="5029200" y="3152236"/>
              <a:chExt cx="3606472" cy="333763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38800" y="3152236"/>
                <a:ext cx="2996872" cy="3337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5029200" y="3200400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D5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5029200" y="3810000"/>
              <a:ext cx="3596640" cy="299558"/>
              <a:chOff x="5029200" y="3533001"/>
              <a:chExt cx="3596640" cy="299558"/>
            </a:xfrm>
          </p:grpSpPr>
          <p:pic>
            <p:nvPicPr>
              <p:cNvPr id="23" name="Picture 4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38800" y="3540982"/>
                <a:ext cx="2987040" cy="2915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5029200" y="3533001"/>
                <a:ext cx="76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4953000" y="2478491"/>
              <a:ext cx="3672840" cy="417109"/>
              <a:chOff x="4953000" y="2133600"/>
              <a:chExt cx="3672840" cy="417109"/>
            </a:xfrm>
          </p:grpSpPr>
          <p:pic>
            <p:nvPicPr>
              <p:cNvPr id="5122" name="Picture 2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38800" y="2133600"/>
                <a:ext cx="2987040" cy="417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4953000" y="2209800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TextBox 36"/>
            <p:cNvSpPr txBox="1"/>
            <p:nvPr/>
          </p:nvSpPr>
          <p:spPr>
            <a:xfrm>
              <a:off x="5093914" y="2237601"/>
              <a:ext cx="38976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xy       +          -           +         -          +          -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5715000" y="2286000"/>
              <a:ext cx="76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6781800" y="2291296"/>
              <a:ext cx="76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7772400" y="2291296"/>
              <a:ext cx="76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5791200" y="1871038"/>
              <a:ext cx="817756" cy="36933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3/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SF3si1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789304" y="1828800"/>
              <a:ext cx="9830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3/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SF3si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787270" y="1828800"/>
              <a:ext cx="8995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3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UCs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701621" y="990600"/>
            <a:ext cx="4572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953000" y="990600"/>
            <a:ext cx="4572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49000" y="4648200"/>
            <a:ext cx="8085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nockdown of SRSF3 suppresses the expression of BRCA1, BRIP1 and RAD51 in SKOV3 cells. The SKOV3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bline cells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KOV3/SRSF3si1, SKOV3/SRSF3si2 and SKOV3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UCs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were grown in the presence or absence of Doxy for three days before total RNAs were extracted or whole cell lysates were prepared. (A) Regular RT-PCR results. (B) Western blotting result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22851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228600" y="152400"/>
            <a:ext cx="8382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2895600" y="76200"/>
            <a:ext cx="2765547" cy="2182604"/>
            <a:chOff x="2895600" y="789196"/>
            <a:chExt cx="2765547" cy="2182604"/>
          </a:xfrm>
        </p:grpSpPr>
        <p:grpSp>
          <p:nvGrpSpPr>
            <p:cNvPr id="7" name="Group 6"/>
            <p:cNvGrpSpPr/>
            <p:nvPr/>
          </p:nvGrpSpPr>
          <p:grpSpPr>
            <a:xfrm>
              <a:off x="2902194" y="1294795"/>
              <a:ext cx="2682753" cy="457805"/>
              <a:chOff x="2902194" y="1294795"/>
              <a:chExt cx="2682753" cy="457805"/>
            </a:xfrm>
          </p:grpSpPr>
          <p:pic>
            <p:nvPicPr>
              <p:cNvPr id="4100" name="Picture 4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51347" y="1294795"/>
                <a:ext cx="2133600" cy="4578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2902194" y="1370995"/>
                <a:ext cx="549153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2933700" y="1017796"/>
              <a:ext cx="27274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xy      -      +       -      +      -      +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3603747" y="1066195"/>
              <a:ext cx="533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213347" y="106619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899147" y="1066195"/>
              <a:ext cx="533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3451347" y="789196"/>
              <a:ext cx="2209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RNPII    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gG    Inpu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2956047" y="1773461"/>
              <a:ext cx="2628898" cy="436339"/>
              <a:chOff x="2956047" y="1838625"/>
              <a:chExt cx="2628898" cy="436339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2956047" y="1964462"/>
                <a:ext cx="4953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IP1</a:t>
                </a:r>
              </a:p>
            </p:txBody>
          </p:sp>
          <p:pic>
            <p:nvPicPr>
              <p:cNvPr id="26" name="Picture 8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61178" y="1838625"/>
                <a:ext cx="2123767" cy="436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4" name="Group 43"/>
            <p:cNvGrpSpPr/>
            <p:nvPr/>
          </p:nvGrpSpPr>
          <p:grpSpPr>
            <a:xfrm>
              <a:off x="2933700" y="2244351"/>
              <a:ext cx="2645091" cy="346449"/>
              <a:chOff x="2971800" y="1966955"/>
              <a:chExt cx="2645091" cy="346449"/>
            </a:xfrm>
          </p:grpSpPr>
          <p:sp>
            <p:nvSpPr>
              <p:cNvPr id="45" name="TextBox 44"/>
              <p:cNvSpPr txBox="1"/>
              <p:nvPr/>
            </p:nvSpPr>
            <p:spPr>
              <a:xfrm>
                <a:off x="2971800" y="2047847"/>
                <a:ext cx="5334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D51</a:t>
                </a:r>
              </a:p>
            </p:txBody>
          </p:sp>
          <p:pic>
            <p:nvPicPr>
              <p:cNvPr id="46" name="Picture 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05200" y="1966955"/>
                <a:ext cx="2111691" cy="3464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8" name="Group 47"/>
            <p:cNvGrpSpPr/>
            <p:nvPr/>
          </p:nvGrpSpPr>
          <p:grpSpPr>
            <a:xfrm>
              <a:off x="2895600" y="2624017"/>
              <a:ext cx="2683191" cy="347783"/>
              <a:chOff x="2934470" y="2402699"/>
              <a:chExt cx="2683191" cy="347783"/>
            </a:xfrm>
          </p:grpSpPr>
          <p:pic>
            <p:nvPicPr>
              <p:cNvPr id="49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05200" y="2402699"/>
                <a:ext cx="2112461" cy="3477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2934470" y="2482334"/>
                <a:ext cx="5715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</p:grpSp>
      </p:grpSp>
      <p:sp>
        <p:nvSpPr>
          <p:cNvPr id="4" name="TextBox 3"/>
          <p:cNvSpPr txBox="1"/>
          <p:nvPr/>
        </p:nvSpPr>
        <p:spPr>
          <a:xfrm>
            <a:off x="2209800" y="0"/>
            <a:ext cx="316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74747" y="5105400"/>
            <a:ext cx="8763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nockdown of SRSF3 reduce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NAp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ccupancy on BRCA1, BRIP1 and RAD51 genes. Shown are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sults in the region of 10 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 kb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wnstream of transcription start site. The primer pairs for PCR are following: For BRCA1, 5’-TCAGTGAAAGCAAACTGCAAGC-3’ and 5’-ACCCTTAGAAGGGGGAATGC-3’; for BRIP1, 5’-TGGGTCATGTGACAGCCATAA-3’ and 5’-CCATGCAGTTTCACTTGAACGA-3’;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D51, 5’-CTTTCTGATGAGCTCCAAGAACAT-3’ and 5’-TCTGGGTCTTCCCAGTTCGG-3’, and for GAPDH, 5’-TTATTCTAGGGTCTGGGGCAGAG-3’ and 5’-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AATGGTTCTCGAAGCAAGCAAG-3’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gular PCR amplificat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precipita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hromatin DN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precipita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hromatin DNA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a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precipita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NAs expressed as percentages of corresponding input DNAs (mean ±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.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n=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** indicates p&lt;0.01 </a:t>
            </a:r>
            <a:r>
              <a:rPr lang="en-US" sz="1200" dirty="0"/>
              <a:t>for comparisons of </a:t>
            </a:r>
            <a:r>
              <a:rPr lang="en-US" sz="1200" dirty="0" err="1"/>
              <a:t>RNApII</a:t>
            </a:r>
            <a:r>
              <a:rPr lang="en-US" sz="1200" dirty="0"/>
              <a:t> occupancy between samples treated with and without </a:t>
            </a:r>
            <a:r>
              <a:rPr lang="en-US" sz="1200" dirty="0" smtClean="0"/>
              <a:t>Doxy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228600" y="2209800"/>
            <a:ext cx="8634413" cy="2895600"/>
            <a:chOff x="228600" y="2209800"/>
            <a:chExt cx="8634413" cy="2895600"/>
          </a:xfrm>
        </p:grpSpPr>
        <p:grpSp>
          <p:nvGrpSpPr>
            <p:cNvPr id="10" name="Group 9"/>
            <p:cNvGrpSpPr/>
            <p:nvPr/>
          </p:nvGrpSpPr>
          <p:grpSpPr>
            <a:xfrm>
              <a:off x="228600" y="2209800"/>
              <a:ext cx="8634413" cy="2895600"/>
              <a:chOff x="228600" y="2362200"/>
              <a:chExt cx="8634413" cy="2895600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28600" y="2514600"/>
                <a:ext cx="8634413" cy="2743200"/>
                <a:chOff x="347662" y="3505200"/>
                <a:chExt cx="8634413" cy="2743200"/>
              </a:xfrm>
            </p:grpSpPr>
            <p:graphicFrame>
              <p:nvGraphicFramePr>
                <p:cNvPr id="19" name="Chart 1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87114668"/>
                    </p:ext>
                  </p:extLst>
                </p:nvPr>
              </p:nvGraphicFramePr>
              <p:xfrm>
                <a:off x="347662" y="3505200"/>
                <a:ext cx="20478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aphicFrame>
              <p:nvGraphicFramePr>
                <p:cNvPr id="20" name="Chart 1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61325870"/>
                    </p:ext>
                  </p:extLst>
                </p:nvPr>
              </p:nvGraphicFramePr>
              <p:xfrm>
                <a:off x="2542785" y="3505200"/>
                <a:ext cx="20478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aphicFrame>
              <p:nvGraphicFramePr>
                <p:cNvPr id="27" name="Chart 2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77950010"/>
                    </p:ext>
                  </p:extLst>
                </p:nvPr>
              </p:nvGraphicFramePr>
              <p:xfrm>
                <a:off x="4767865" y="3505200"/>
                <a:ext cx="20478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graphicFrame>
              <p:nvGraphicFramePr>
                <p:cNvPr id="30" name="Chart 2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59252338"/>
                    </p:ext>
                  </p:extLst>
                </p:nvPr>
              </p:nvGraphicFramePr>
              <p:xfrm>
                <a:off x="6934200" y="3505200"/>
                <a:ext cx="20478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</p:grpSp>
          <p:sp>
            <p:nvSpPr>
              <p:cNvPr id="31" name="TextBox 30"/>
              <p:cNvSpPr txBox="1"/>
              <p:nvPr/>
            </p:nvSpPr>
            <p:spPr>
              <a:xfrm>
                <a:off x="228600" y="2362200"/>
                <a:ext cx="40742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1516380" y="39624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733800" y="40386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943600" y="41910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4903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16161" y="2120262"/>
            <a:ext cx="3315069" cy="1293127"/>
            <a:chOff x="2716161" y="2120262"/>
            <a:chExt cx="3315069" cy="1293127"/>
          </a:xfrm>
        </p:grpSpPr>
        <p:grpSp>
          <p:nvGrpSpPr>
            <p:cNvPr id="3" name="Group 2"/>
            <p:cNvGrpSpPr/>
            <p:nvPr/>
          </p:nvGrpSpPr>
          <p:grpSpPr>
            <a:xfrm>
              <a:off x="2716161" y="2571135"/>
              <a:ext cx="3315069" cy="476865"/>
              <a:chOff x="2716161" y="2571135"/>
              <a:chExt cx="3315069" cy="476865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52800" y="2571135"/>
                <a:ext cx="2678430" cy="4768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2716161" y="2765011"/>
                <a:ext cx="6096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H2AX </a:t>
                </a:r>
                <a:endParaRPr lang="en-US" sz="12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2760406" y="3124200"/>
              <a:ext cx="3270824" cy="289189"/>
              <a:chOff x="2760406" y="3158428"/>
              <a:chExt cx="3270824" cy="289189"/>
            </a:xfrm>
          </p:grpSpPr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70006" y="3158428"/>
                <a:ext cx="2661224" cy="2891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2760406" y="3210689"/>
                <a:ext cx="6096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3581400" y="2323182"/>
              <a:ext cx="2449830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1         2       3       4        5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29203" y="2120262"/>
              <a:ext cx="1885797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s after Doxy treatment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1000" y="367844"/>
            <a:ext cx="8382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49315" y="3962400"/>
            <a:ext cx="8085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6 –Time course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γ-H2AX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A2780/SRSF3si2 cells treated with Doxy. Day 0 represents cells that were not treated with Doxy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290921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-102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" y="508000"/>
            <a:ext cx="1905000" cy="63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 Box -1022"/>
          <p:cNvSpPr txBox="1">
            <a:spLocks noChangeArrowheads="1"/>
          </p:cNvSpPr>
          <p:nvPr/>
        </p:nvSpPr>
        <p:spPr bwMode="auto">
          <a:xfrm>
            <a:off x="2286000" y="558800"/>
            <a:ext cx="5080000" cy="38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/>
            <a:r>
              <a:rPr lang="en-US" altLang="en-US" sz="1400">
                <a:latin typeface="Trebuchet MS" pitchFamily="34" charset="0"/>
              </a:rPr>
              <a:t>Comparison of Selected Genes in TCGA Ovarian</a:t>
            </a:r>
            <a:endParaRPr lang="en-US" altLang="en-US" sz="900">
              <a:latin typeface="Trebuchet MS" pitchFamily="34" charset="0"/>
            </a:endParaRPr>
          </a:p>
          <a:p>
            <a:pPr algn="ctr"/>
            <a:r>
              <a:rPr lang="en-US" altLang="en-US" sz="900">
                <a:latin typeface="Trebuchet MS" pitchFamily="34" charset="0"/>
              </a:rPr>
              <a:t>Over-expression in Ovarian Serous Cystadenocarcinoma vs. Normal</a:t>
            </a:r>
          </a:p>
          <a:p>
            <a:pPr algn="ctr"/>
            <a:r>
              <a:rPr lang="en-US" altLang="en-US" sz="900">
                <a:latin typeface="Trebuchet MS" pitchFamily="34" charset="0"/>
              </a:rPr>
              <a:t>log2 median-centered intensity</a:t>
            </a:r>
          </a:p>
        </p:txBody>
      </p:sp>
      <p:pic>
        <p:nvPicPr>
          <p:cNvPr id="3" name="Picture -102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" y="1244600"/>
            <a:ext cx="8890000" cy="165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 Box -1020"/>
          <p:cNvSpPr txBox="1">
            <a:spLocks noChangeArrowheads="1"/>
          </p:cNvSpPr>
          <p:nvPr/>
        </p:nvSpPr>
        <p:spPr bwMode="auto">
          <a:xfrm>
            <a:off x="254000" y="2971800"/>
            <a:ext cx="3810000" cy="31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en-US" sz="1000" b="1">
                <a:latin typeface="Trebuchet MS" pitchFamily="34" charset="0"/>
              </a:rPr>
              <a:t>Legend</a:t>
            </a:r>
          </a:p>
        </p:txBody>
      </p:sp>
      <p:sp>
        <p:nvSpPr>
          <p:cNvPr id="5" name="Line -1019"/>
          <p:cNvSpPr>
            <a:spLocks noChangeShapeType="1"/>
          </p:cNvSpPr>
          <p:nvPr/>
        </p:nvSpPr>
        <p:spPr bwMode="auto">
          <a:xfrm>
            <a:off x="254000" y="3200400"/>
            <a:ext cx="4178300" cy="0"/>
          </a:xfrm>
          <a:prstGeom prst="line">
            <a:avLst/>
          </a:prstGeom>
          <a:noFill/>
          <a:ln w="38100">
            <a:solidFill>
              <a:srgbClr val="C0C0C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" name="Text Box -1018"/>
          <p:cNvSpPr txBox="1">
            <a:spLocks noChangeArrowheads="1"/>
          </p:cNvSpPr>
          <p:nvPr/>
        </p:nvSpPr>
        <p:spPr bwMode="auto">
          <a:xfrm>
            <a:off x="254000" y="3200400"/>
            <a:ext cx="3937000" cy="31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en-US" sz="900" dirty="0">
                <a:solidFill>
                  <a:srgbClr val="000000"/>
                </a:solidFill>
                <a:latin typeface="Trebuchet MS" pitchFamily="34" charset="0"/>
              </a:rPr>
              <a:t>1. Ovary (8)  </a:t>
            </a:r>
            <a:r>
              <a:rPr lang="en-US" altLang="en-US" sz="900" b="1" dirty="0">
                <a:solidFill>
                  <a:srgbClr val="5587B7"/>
                </a:solidFill>
                <a:latin typeface="Trebuchet MS" pitchFamily="34" charset="0"/>
              </a:rPr>
              <a:t>2. Ovarian Serous </a:t>
            </a:r>
            <a:r>
              <a:rPr lang="en-US" altLang="en-US" sz="900" b="1" dirty="0" err="1">
                <a:solidFill>
                  <a:srgbClr val="5587B7"/>
                </a:solidFill>
                <a:latin typeface="Trebuchet MS" pitchFamily="34" charset="0"/>
              </a:rPr>
              <a:t>Cystadenocarcinoma</a:t>
            </a:r>
            <a:r>
              <a:rPr lang="en-US" altLang="en-US" sz="900" b="1" dirty="0">
                <a:solidFill>
                  <a:srgbClr val="5587B7"/>
                </a:solidFill>
                <a:latin typeface="Trebuchet MS" pitchFamily="34" charset="0"/>
              </a:rPr>
              <a:t> (586)  </a:t>
            </a:r>
          </a:p>
        </p:txBody>
      </p:sp>
      <p:sp>
        <p:nvSpPr>
          <p:cNvPr id="7" name="Text Box -1017"/>
          <p:cNvSpPr txBox="1">
            <a:spLocks noChangeArrowheads="1"/>
          </p:cNvSpPr>
          <p:nvPr/>
        </p:nvSpPr>
        <p:spPr bwMode="auto">
          <a:xfrm>
            <a:off x="4686300" y="2971800"/>
            <a:ext cx="3810000" cy="31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en-US" sz="1000" b="1">
                <a:latin typeface="Trebuchet MS" pitchFamily="34" charset="0"/>
              </a:rPr>
              <a:t>TCGA Ovarian</a:t>
            </a:r>
          </a:p>
        </p:txBody>
      </p:sp>
      <p:sp>
        <p:nvSpPr>
          <p:cNvPr id="8" name="Line -1016"/>
          <p:cNvSpPr>
            <a:spLocks noChangeShapeType="1"/>
          </p:cNvSpPr>
          <p:nvPr/>
        </p:nvSpPr>
        <p:spPr bwMode="auto">
          <a:xfrm>
            <a:off x="4686300" y="3200400"/>
            <a:ext cx="4178300" cy="0"/>
          </a:xfrm>
          <a:prstGeom prst="line">
            <a:avLst/>
          </a:prstGeom>
          <a:noFill/>
          <a:ln w="38100">
            <a:solidFill>
              <a:srgbClr val="C0C0C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aphicFrame>
        <p:nvGraphicFramePr>
          <p:cNvPr id="13" name="Group -10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136920"/>
              </p:ext>
            </p:extLst>
          </p:nvPr>
        </p:nvGraphicFramePr>
        <p:xfrm>
          <a:off x="4686300" y="3200400"/>
          <a:ext cx="5080000" cy="685800"/>
        </p:xfrm>
        <a:graphic>
          <a:graphicData uri="http://schemas.openxmlformats.org/drawingml/2006/table">
            <a:tbl>
              <a:tblPr/>
              <a:tblGrid>
                <a:gridCol w="2540000"/>
                <a:gridCol w="2540000"/>
              </a:tblGrid>
              <a:tr h="228600"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rebuchet MS" pitchFamily="34" charset="0"/>
                        </a:rPr>
                        <a:t>No Associated Paper 2013/06/03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rebuchet MS" pitchFamily="34" charset="0"/>
                        </a:rPr>
                        <a:t>594 samples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rebuchet MS" pitchFamily="34" charset="0"/>
                        </a:rPr>
                        <a:t>mRNA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rebuchet MS" pitchFamily="34" charset="0"/>
                        </a:rPr>
                        <a:t>12,624 measured genes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rebuchet MS" pitchFamily="34" charset="0"/>
                        </a:rPr>
                        <a:t>Human Genome U133A Array</a:t>
                      </a: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marL="382588" indent="-382588" defTabSz="1019175">
                        <a:spcBef>
                          <a:spcPct val="20000"/>
                        </a:spcBef>
                        <a:defRPr sz="32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1pPr>
                      <a:lvl2pPr marL="827088" indent="-317500" defTabSz="1019175">
                        <a:spcBef>
                          <a:spcPct val="20000"/>
                        </a:spcBef>
                        <a:defRPr sz="27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2pPr>
                      <a:lvl3pPr marL="1273175" indent="-254000" defTabSz="1019175">
                        <a:spcBef>
                          <a:spcPct val="20000"/>
                        </a:spcBef>
                        <a:defRPr sz="23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3pPr>
                      <a:lvl4pPr marL="1782763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4pPr>
                      <a:lvl5pPr marL="2292350" indent="-254000" defTabSz="1019175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5pPr>
                      <a:lvl6pPr marL="27495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6pPr>
                      <a:lvl7pPr marL="32067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7pPr>
                      <a:lvl8pPr marL="36639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8pPr>
                      <a:lvl9pPr marL="4121150" indent="-254000" defTabSz="1019175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Times New Roman" pitchFamily="18" charset="0"/>
                        </a:defRPr>
                      </a:lvl9pPr>
                    </a:lstStyle>
                    <a:p>
                      <a:pPr marL="382588" marR="0" lvl="0" indent="-382588" algn="l" defTabSz="1019175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9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rebuchet MS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10" name="Picture -101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3300" y="4038600"/>
            <a:ext cx="3657600" cy="31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 Box -1013"/>
          <p:cNvSpPr txBox="1">
            <a:spLocks noChangeArrowheads="1"/>
          </p:cNvSpPr>
          <p:nvPr/>
        </p:nvSpPr>
        <p:spPr bwMode="auto">
          <a:xfrm>
            <a:off x="4813300" y="4356100"/>
            <a:ext cx="3492500" cy="317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en-US" sz="600">
                <a:latin typeface="Trebuchet MS" pitchFamily="34" charset="0"/>
              </a:rPr>
              <a:t>Note: Colors are z-score normalized to depict relative values within rows. They cannot be used to compare values between rows.</a:t>
            </a:r>
          </a:p>
        </p:txBody>
      </p:sp>
      <p:sp>
        <p:nvSpPr>
          <p:cNvPr id="12" name="Text Box -1012"/>
          <p:cNvSpPr txBox="1">
            <a:spLocks noChangeArrowheads="1"/>
          </p:cNvSpPr>
          <p:nvPr/>
        </p:nvSpPr>
        <p:spPr bwMode="auto">
          <a:xfrm>
            <a:off x="76200" y="4826000"/>
            <a:ext cx="8890000" cy="99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r>
              <a:rPr lang="en-US" altLang="en-US" sz="800" dirty="0">
                <a:latin typeface="Trebuchet MS" pitchFamily="34" charset="0"/>
              </a:rPr>
              <a:t>© 2013 Life Technologies Corporation. All rights reserved. Images from the </a:t>
            </a:r>
            <a:r>
              <a:rPr lang="en-US" altLang="en-US" sz="800" dirty="0" err="1">
                <a:latin typeface="Trebuchet MS" pitchFamily="34" charset="0"/>
              </a:rPr>
              <a:t>Oncomine</a:t>
            </a:r>
            <a:r>
              <a:rPr lang="en-US" altLang="en-US" sz="800" dirty="0">
                <a:latin typeface="Trebuchet MS" pitchFamily="34" charset="0"/>
              </a:rPr>
              <a:t>™ Platform may be used in publications with proper citation. The citation is as follows: The </a:t>
            </a:r>
            <a:r>
              <a:rPr lang="en-US" altLang="en-US" sz="800" dirty="0" err="1">
                <a:latin typeface="Trebuchet MS" pitchFamily="34" charset="0"/>
              </a:rPr>
              <a:t>Oncomine</a:t>
            </a:r>
            <a:r>
              <a:rPr lang="en-US" altLang="en-US" sz="800" dirty="0">
                <a:latin typeface="Trebuchet MS" pitchFamily="34" charset="0"/>
              </a:rPr>
              <a:t>™ Platform (Life Technologies, Ann Arbor, MI) was used for analysis and visualization. For further information, refer to the terms of use.</a:t>
            </a:r>
          </a:p>
          <a:p>
            <a:endParaRPr lang="en-US" altLang="en-US" sz="800" dirty="0">
              <a:latin typeface="Trebuchet MS" pitchFamily="34" charset="0"/>
            </a:endParaRPr>
          </a:p>
          <a:p>
            <a:r>
              <a:rPr lang="en-US" altLang="en-US" sz="800" dirty="0" err="1">
                <a:latin typeface="Trebuchet MS" pitchFamily="34" charset="0"/>
              </a:rPr>
              <a:t>Oncomine</a:t>
            </a:r>
            <a:r>
              <a:rPr lang="en-US" altLang="en-US" sz="800" dirty="0">
                <a:latin typeface="Trebuchet MS" pitchFamily="34" charset="0"/>
              </a:rPr>
              <a:t> Source:  https://www.oncomine.com/resource/main.html#a:1974;ac:2968,1974;cso:sizeSmallLarge;cv:detail;d:111287677;dso:geneOverex;dt:predefinedClass;ec:[2,1,5];epv:108715,1355,150001.151078,1627.1768,3508,923;et:over;f:555123;g:25788;gdt:mrna;p:200001355;pg:1;pvf:1459,3445,5852,5989,6019,32898,32905,34860,39561,150004;scr:datasets;ss:analysis;th:g100.0,p0.001,fc1.5;v:1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8600" y="152400"/>
            <a:ext cx="1066800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sp>
        <p:nvSpPr>
          <p:cNvPr id="17" name="Rectangle 16"/>
          <p:cNvSpPr/>
          <p:nvPr/>
        </p:nvSpPr>
        <p:spPr>
          <a:xfrm>
            <a:off x="449000" y="5943600"/>
            <a:ext cx="8085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 Analysis of ovarian serous cystadenocarcinoma microarray data from TCGA  project. The analysis was conducted online using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comin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rogram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221565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50</TotalTime>
  <Words>861</Words>
  <Application>Microsoft Office PowerPoint</Application>
  <PresentationFormat>On-screen Show (4:3)</PresentationFormat>
  <Paragraphs>222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long He</dc:creator>
  <cp:lastModifiedBy>Xiaolong He</cp:lastModifiedBy>
  <cp:revision>49</cp:revision>
  <dcterms:created xsi:type="dcterms:W3CDTF">2015-01-13T22:23:53Z</dcterms:created>
  <dcterms:modified xsi:type="dcterms:W3CDTF">2015-07-27T13:39:27Z</dcterms:modified>
</cp:coreProperties>
</file>